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jpeg" ContentType="image/jpeg"/>
  <Override PartName="/ppt/media/image3.png" ContentType="image/png"/>
  <Override PartName="/ppt/media/image4.jpeg" ContentType="image/jpeg"/>
  <Override PartName="/ppt/media/image5.png" ContentType="image/png"/>
  <Override PartName="/ppt/media/image6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6088" cy="9982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34C11C-BA8D-426C-97E1-431BADB7C0D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8CBF75-A9CD-4091-A070-DBB4B9E4BF8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3A0324-0EF9-4E02-9230-C28925F343A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B97161-1686-4E76-A988-B34A5F64644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62C71C-582B-4189-9DD0-5BB3F54063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F029D2-8538-4FF6-A8E4-7EBFEBB3B5C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6BECAB-4727-4EAA-BC62-CE12E29E8F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EA8722-9CE3-4BCA-A690-B4A329DE915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DBE853-7142-4177-9729-C45DE0035A2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AF0F2F-80B6-471B-8986-A3150FEC2A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AE1E22-6052-40D3-8F29-858DE93667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F720DF-7F98-476C-B5A7-D95DBC2E2F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21D0752-DA2D-46C8-BC95-26DA766B356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image" Target="../media/image4.jpeg"/><Relationship Id="rId5" Type="http://schemas.openxmlformats.org/officeDocument/2006/relationships/image" Target="../media/image5.png"/><Relationship Id="rId6" Type="http://schemas.openxmlformats.org/officeDocument/2006/relationships/image" Target="../media/image6.jpe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178000" y="3259080"/>
            <a:ext cx="1172880" cy="215640"/>
            <a:chOff x="2178000" y="3259080"/>
            <a:chExt cx="1172880" cy="215640"/>
          </a:xfrm>
        </p:grpSpPr>
        <p:pic>
          <p:nvPicPr>
            <p:cNvPr id="42" name="" descr=""/>
            <p:cNvPicPr/>
            <p:nvPr/>
          </p:nvPicPr>
          <p:blipFill>
            <a:blip r:embed="rId1"/>
            <a:srcRect l="57246" t="10123" r="0" b="0"/>
            <a:stretch/>
          </p:blipFill>
          <p:spPr>
            <a:xfrm>
              <a:off x="2602800" y="3259080"/>
              <a:ext cx="748080" cy="210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" descr=""/>
            <p:cNvPicPr/>
            <p:nvPr/>
          </p:nvPicPr>
          <p:blipFill>
            <a:blip r:embed="rId2"/>
            <a:srcRect l="0" t="3988" r="75080" b="8129"/>
            <a:stretch/>
          </p:blipFill>
          <p:spPr>
            <a:xfrm>
              <a:off x="2178000" y="3263760"/>
              <a:ext cx="426240" cy="206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"/>
            <p:cNvSpPr/>
            <p:nvPr/>
          </p:nvSpPr>
          <p:spPr>
            <a:xfrm>
              <a:off x="2189880" y="3259080"/>
              <a:ext cx="1144800" cy="2156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5" name=""/>
          <p:cNvSpPr/>
          <p:nvPr/>
        </p:nvSpPr>
        <p:spPr>
          <a:xfrm>
            <a:off x="2107080" y="1363680"/>
            <a:ext cx="49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Arial"/>
              </a:rPr>
              <a:t>Jurkat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655360" y="1363680"/>
            <a:ext cx="384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Arial"/>
              </a:rPr>
              <a:t>B1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973600" y="1363680"/>
            <a:ext cx="4564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Arial"/>
              </a:rPr>
              <a:t>66cl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3547800" y="2163600"/>
            <a:ext cx="735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Arial"/>
              </a:rPr>
              <a:t>IP + WB: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it-IT" sz="900" spc="-1" strike="noStrike">
                <a:solidFill>
                  <a:srgbClr val="000000"/>
                </a:solidFill>
                <a:latin typeface="Arial"/>
              </a:rPr>
              <a:t>-Sema4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545640" y="3171960"/>
            <a:ext cx="942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Arial"/>
              </a:rPr>
              <a:t>Total lysat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Arial"/>
              </a:rPr>
              <a:t>WB: </a:t>
            </a:r>
            <a:r>
              <a:rPr b="0" lang="it-IT" sz="9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it-IT" sz="900" spc="-1" strike="noStrike">
                <a:solidFill>
                  <a:srgbClr val="000000"/>
                </a:solidFill>
                <a:latin typeface="Arial"/>
              </a:rPr>
              <a:t>-Vinculi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1808280" y="238140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808280" y="160812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808280" y="273204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244160" y="1488960"/>
            <a:ext cx="577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</a:rPr>
              <a:t>196 KD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1244160" y="2259000"/>
            <a:ext cx="577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</a:rPr>
              <a:t>116 KD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1307160" y="2606760"/>
            <a:ext cx="52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</a:rPr>
              <a:t>97 KD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6" name="" descr=""/>
          <p:cNvPicPr/>
          <p:nvPr/>
        </p:nvPicPr>
        <p:blipFill>
          <a:blip r:embed="rId3"/>
          <a:srcRect l="11079" t="12051" r="66819" b="50780"/>
          <a:stretch/>
        </p:blipFill>
        <p:spPr>
          <a:xfrm>
            <a:off x="2033640" y="1598760"/>
            <a:ext cx="576360" cy="1449360"/>
          </a:xfrm>
          <a:prstGeom prst="rect">
            <a:avLst/>
          </a:prstGeom>
          <a:ln w="0">
            <a:noFill/>
          </a:ln>
        </p:spPr>
      </p:pic>
      <p:pic>
        <p:nvPicPr>
          <p:cNvPr id="57" name="" descr=""/>
          <p:cNvPicPr/>
          <p:nvPr/>
        </p:nvPicPr>
        <p:blipFill>
          <a:blip r:embed="rId4"/>
          <a:srcRect l="59777" t="5285" r="2560" b="51289"/>
          <a:stretch/>
        </p:blipFill>
        <p:spPr>
          <a:xfrm>
            <a:off x="2619360" y="1598760"/>
            <a:ext cx="863640" cy="1449360"/>
          </a:xfrm>
          <a:prstGeom prst="rect">
            <a:avLst/>
          </a:prstGeom>
          <a:ln w="0">
            <a:noFill/>
          </a:ln>
        </p:spPr>
      </p:pic>
      <p:sp>
        <p:nvSpPr>
          <p:cNvPr id="58" name=""/>
          <p:cNvSpPr/>
          <p:nvPr/>
        </p:nvSpPr>
        <p:spPr>
          <a:xfrm>
            <a:off x="2033640" y="1598760"/>
            <a:ext cx="1439640" cy="1430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2610000" y="1601640"/>
            <a:ext cx="0" cy="14274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0" name="" descr=""/>
          <p:cNvPicPr/>
          <p:nvPr/>
        </p:nvPicPr>
        <p:blipFill>
          <a:blip r:embed="rId5"/>
          <a:stretch/>
        </p:blipFill>
        <p:spPr>
          <a:xfrm>
            <a:off x="2106720" y="4473720"/>
            <a:ext cx="1224000" cy="9712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61" name=""/>
          <p:cNvSpPr/>
          <p:nvPr/>
        </p:nvSpPr>
        <p:spPr>
          <a:xfrm>
            <a:off x="3474360" y="4761000"/>
            <a:ext cx="9961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Arial"/>
              </a:rPr>
              <a:t>IHC: </a:t>
            </a:r>
            <a:r>
              <a:rPr b="0" lang="it-IT" sz="9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it-IT" sz="900" spc="-1" strike="noStrike">
                <a:solidFill>
                  <a:srgbClr val="000000"/>
                </a:solidFill>
                <a:latin typeface="Arial"/>
              </a:rPr>
              <a:t>-Sema4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955800" y="101592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955800" y="395280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4988160" y="101592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2361240" y="4200480"/>
            <a:ext cx="7095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Arial"/>
              </a:rPr>
              <a:t>B16 tumor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" name="" descr=""/>
          <p:cNvPicPr/>
          <p:nvPr/>
        </p:nvPicPr>
        <p:blipFill>
          <a:blip r:embed="rId6"/>
          <a:stretch/>
        </p:blipFill>
        <p:spPr>
          <a:xfrm>
            <a:off x="5491080" y="1808280"/>
            <a:ext cx="2394000" cy="3841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67" name=""/>
          <p:cNvSpPr/>
          <p:nvPr/>
        </p:nvSpPr>
        <p:spPr>
          <a:xfrm>
            <a:off x="5452560" y="1566720"/>
            <a:ext cx="700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Arial"/>
              </a:rPr>
              <a:t>SK  HU   </a:t>
            </a: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6322680" y="1566720"/>
            <a:ext cx="700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Arial"/>
              </a:rPr>
              <a:t>SK  HU   </a:t>
            </a: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7168680" y="1566720"/>
            <a:ext cx="700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Arial"/>
              </a:rPr>
              <a:t>SK  HU   </a:t>
            </a: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5510160" y="2262240"/>
            <a:ext cx="635040" cy="352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Arial"/>
              </a:rPr>
              <a:t>PlexinB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</a:rPr>
              <a:t>(119bp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6354720" y="2262240"/>
            <a:ext cx="635040" cy="352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Arial"/>
              </a:rPr>
              <a:t>PlexinB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</a:rPr>
              <a:t>(59 bp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7259760" y="2262240"/>
            <a:ext cx="558720" cy="352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it-IT" sz="900" spc="-1" strike="noStrike">
                <a:solidFill>
                  <a:srgbClr val="000000"/>
                </a:solidFill>
                <a:latin typeface="Arial"/>
              </a:rPr>
              <a:t>-acti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</a:rPr>
              <a:t>(171 bp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5543640" y="2259000"/>
            <a:ext cx="576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6397560" y="2259000"/>
            <a:ext cx="576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7253280" y="2259000"/>
            <a:ext cx="576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457200" y="304920"/>
            <a:ext cx="8229600" cy="38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Arial"/>
              </a:rPr>
              <a:t>Additional File 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4-19T13:20:01Z</dcterms:created>
  <dc:creator>ltamagnone</dc:creator>
  <dc:description/>
  <dc:language>en-US</dc:language>
  <cp:lastModifiedBy>ltamagnone</cp:lastModifiedBy>
  <dcterms:modified xsi:type="dcterms:W3CDTF">2007-05-23T14:04:17Z</dcterms:modified>
  <cp:revision>8</cp:revision>
  <dc:subject/>
  <dc:title>Slide 1</dc:title>
</cp:coreProperties>
</file>